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59" r:id="rId4"/>
    <p:sldId id="258" r:id="rId5"/>
    <p:sldId id="260" r:id="rId6"/>
    <p:sldId id="262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3" d="100"/>
          <a:sy n="83" d="100"/>
        </p:scale>
        <p:origin x="40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AD3EEC-6BC6-A797-2755-42C7824264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2928B6A-0DB6-C83B-AC9C-F9AFE4EE50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20570B-5658-5E04-F2A3-6B852851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FC6726-89FF-3743-BBE4-339A68CD9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C9CB36-87B1-8EA1-167F-39BA4EFCC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3224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D52C41-5135-BA33-EC62-21B5E70D26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3DAF3D7-4F47-F0AF-1F43-6F83ADFA7D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9AF0B89-4F46-0670-8591-A48393EC1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7D36A5-57D3-13ED-644D-CC924ACD5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55A235-1FA9-1A18-C202-8A41030C9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2471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FE1ADB6-0A6B-BF68-660D-33B5C11780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D42861C-A8F6-268B-92CD-8E4EB3EA4D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E6E744-8FB3-2351-93FC-9C1322BD7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4AF847-8E0D-D287-19BA-26CDF0740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28BDB4-1786-B7F5-1043-D26D2C2B9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3102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A32860-7BBF-26B7-8DDF-A95BEB4A4A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AFA8DB4-F00B-5D47-D83C-B81C43D212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F88C72-7FAA-52A7-E121-C193F2AC4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D854AE-690F-D2AF-1C82-2DACBB094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4D33B8-A7C6-FD4E-7BEA-274AFE12B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2461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B5A889-EA0D-E903-D1BB-921376F4A9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741DBF4-9CBB-8B68-5E0A-A0CBDFBBAD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289CC2-83D1-0D60-10F5-F78F2DF56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945BE2-36DD-6CE9-51F7-CBE41FAA5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B7EFE8F-5E76-D5FB-C563-7E8199F5E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9297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7D5A39-1E3F-8528-CCDD-0E5A2B7211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E8FCFC-00A7-6CEF-4F0E-9A1FAE20FC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A64F6DA-7B96-1674-8401-8AF3347F04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B81B28-0E2E-733E-1565-61067E183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D74883-5569-31C6-049A-E29002D9B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8377B6-C8BD-F6A8-4F6E-EDDA307E4C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51704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BE9F3D-E378-A169-3DD4-07F798EEA5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73E1786-3947-69D4-0AE4-301BA5BD1C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72A9A57-BF01-3CF4-34B7-31054B7FC6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A9B4EC8-5E88-16BC-983B-112D7DDAB2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E272188-228C-9C87-7DB4-DEB3B9C350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F1FD7D1-B617-B7AA-3831-D606B5B85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C0FBA9D-D781-B03E-1F81-FFBF7FA6C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BD05353-09C9-0BFC-780E-5C8FE38B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9317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7EB2CB-A083-7A12-1D63-6403B3055E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2F67B07-14AD-6873-C269-9D14F3240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642A3CC-3E29-B984-CA27-003DE8B1E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294AB29-C168-5B42-BC0C-0A5BE50F3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1174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400F417-9FC2-A49B-9BA0-260F274E7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C8B26B5-6903-EEE3-C181-10CF7059B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398C242-1990-57F4-31B1-4D8718054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0336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F0FD56-364F-64BF-A082-BA298BB53C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890CFD0-0DEC-2881-0E05-C2E13551FF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1A29058-4308-7D3D-FD12-6FB410450C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ACEC9C6-0CA8-157A-4347-50C350690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5ABD855-0273-15B7-7A27-FD202752D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0C62AA-0C08-0061-F80A-7E5575CE5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5920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0A2699-9693-BAED-099A-723BA4D6C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40DDFB7-B3E1-A2BC-5FB2-0ECD89CBC1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EDD1542-BC15-7804-8C31-581232D073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E77289-CA8A-85F4-880B-461C8E707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72F1EB-A72C-3C7A-AD6E-32E374A9A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0F4585-DA05-CA96-D2CF-D206833C1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742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35077D1-8C51-7E6A-4965-7A0D6149DB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3A085AF-D86C-7031-C08E-F10C40CFAC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84EDCB-9004-2C14-01F9-F481087204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EEF96-2829-413B-877D-516126F70E3D}" type="datetimeFigureOut">
              <a:rPr lang="zh-CN" altLang="en-US" smtClean="0"/>
              <a:t>2024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338369-62EC-B547-75CD-FE9403C452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FC5785-40BF-B90F-4F9D-621AB383CB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F4E9AF-BD4E-47CF-984A-D91B21D2A4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7989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4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microsoft.com/office/2007/relationships/hdphoto" Target="../media/hdphoto1.wdp"/><Relationship Id="rId10" Type="http://schemas.openxmlformats.org/officeDocument/2006/relationships/image" Target="../media/image10.png"/><Relationship Id="rId4" Type="http://schemas.openxmlformats.org/officeDocument/2006/relationships/image" Target="../media/image5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8.png"/><Relationship Id="rId3" Type="http://schemas.microsoft.com/office/2007/relationships/hdphoto" Target="../media/hdphoto2.wdp"/><Relationship Id="rId7" Type="http://schemas.openxmlformats.org/officeDocument/2006/relationships/image" Target="../media/image17.png"/><Relationship Id="rId12" Type="http://schemas.openxmlformats.org/officeDocument/2006/relationships/image" Target="../media/image4.png"/><Relationship Id="rId17" Type="http://schemas.microsoft.com/office/2007/relationships/hdphoto" Target="../media/hdphoto3.wdp"/><Relationship Id="rId2" Type="http://schemas.openxmlformats.org/officeDocument/2006/relationships/image" Target="../media/image14.png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11" Type="http://schemas.openxmlformats.org/officeDocument/2006/relationships/image" Target="../media/image20.png"/><Relationship Id="rId5" Type="http://schemas.openxmlformats.org/officeDocument/2006/relationships/image" Target="../media/image16.png"/><Relationship Id="rId15" Type="http://schemas.openxmlformats.org/officeDocument/2006/relationships/image" Target="../media/image22.png"/><Relationship Id="rId10" Type="http://schemas.openxmlformats.org/officeDocument/2006/relationships/image" Target="../media/image19.png"/><Relationship Id="rId4" Type="http://schemas.openxmlformats.org/officeDocument/2006/relationships/image" Target="../media/image15.png"/><Relationship Id="rId9" Type="http://schemas.openxmlformats.org/officeDocument/2006/relationships/image" Target="../media/image18.png"/><Relationship Id="rId1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4.png"/><Relationship Id="rId18" Type="http://schemas.openxmlformats.org/officeDocument/2006/relationships/image" Target="../media/image38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12" Type="http://schemas.openxmlformats.org/officeDocument/2006/relationships/image" Target="../media/image33.png"/><Relationship Id="rId17" Type="http://schemas.microsoft.com/office/2007/relationships/hdphoto" Target="../media/hdphoto5.wdp"/><Relationship Id="rId2" Type="http://schemas.openxmlformats.org/officeDocument/2006/relationships/image" Target="../media/image24.png"/><Relationship Id="rId16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11" Type="http://schemas.openxmlformats.org/officeDocument/2006/relationships/image" Target="../media/image32.png"/><Relationship Id="rId5" Type="http://schemas.openxmlformats.org/officeDocument/2006/relationships/image" Target="../media/image27.png"/><Relationship Id="rId15" Type="http://schemas.openxmlformats.org/officeDocument/2006/relationships/image" Target="../media/image36.png"/><Relationship Id="rId10" Type="http://schemas.openxmlformats.org/officeDocument/2006/relationships/image" Target="../media/image31.png"/><Relationship Id="rId4" Type="http://schemas.openxmlformats.org/officeDocument/2006/relationships/image" Target="../media/image26.png"/><Relationship Id="rId9" Type="http://schemas.microsoft.com/office/2007/relationships/hdphoto" Target="../media/hdphoto4.wdp"/><Relationship Id="rId14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3" Type="http://schemas.openxmlformats.org/officeDocument/2006/relationships/image" Target="../media/image40.png"/><Relationship Id="rId7" Type="http://schemas.microsoft.com/office/2007/relationships/hdphoto" Target="../media/hdphoto5.wdp"/><Relationship Id="rId12" Type="http://schemas.openxmlformats.org/officeDocument/2006/relationships/image" Target="../media/image47.png"/><Relationship Id="rId17" Type="http://schemas.microsoft.com/office/2007/relationships/hdphoto" Target="../media/hdphoto6.wdp"/><Relationship Id="rId2" Type="http://schemas.openxmlformats.org/officeDocument/2006/relationships/image" Target="../media/image39.png"/><Relationship Id="rId16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11" Type="http://schemas.openxmlformats.org/officeDocument/2006/relationships/image" Target="../media/image46.png"/><Relationship Id="rId5" Type="http://schemas.openxmlformats.org/officeDocument/2006/relationships/image" Target="../media/image42.png"/><Relationship Id="rId15" Type="http://schemas.openxmlformats.org/officeDocument/2006/relationships/image" Target="../media/image50.png"/><Relationship Id="rId10" Type="http://schemas.openxmlformats.org/officeDocument/2006/relationships/image" Target="../media/image45.png"/><Relationship Id="rId4" Type="http://schemas.openxmlformats.org/officeDocument/2006/relationships/image" Target="../media/image41.png"/><Relationship Id="rId9" Type="http://schemas.openxmlformats.org/officeDocument/2006/relationships/image" Target="../media/image44.png"/><Relationship Id="rId14" Type="http://schemas.openxmlformats.org/officeDocument/2006/relationships/image" Target="../media/image4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7" Type="http://schemas.openxmlformats.org/officeDocument/2006/relationships/image" Target="../media/image57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6.png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873943C-2024-6225-FB50-D4AF2601AFC9}"/>
              </a:ext>
            </a:extLst>
          </p:cNvPr>
          <p:cNvSpPr txBox="1"/>
          <p:nvPr/>
        </p:nvSpPr>
        <p:spPr>
          <a:xfrm>
            <a:off x="669365" y="358588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iginal western blot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D82B367-2710-B7FE-2562-EABE713B1DC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259" b="11298"/>
          <a:stretch/>
        </p:blipFill>
        <p:spPr>
          <a:xfrm>
            <a:off x="789802" y="1332752"/>
            <a:ext cx="3419856" cy="86061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78B3D1A-74AF-F306-2388-F9B56BF0E17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63" t="50000" r="5633" b="17707"/>
          <a:stretch/>
        </p:blipFill>
        <p:spPr>
          <a:xfrm>
            <a:off x="4515223" y="1332753"/>
            <a:ext cx="3161553" cy="86061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B833B7AB-CA9E-E296-C820-F7379949F2F9}"/>
              </a:ext>
            </a:extLst>
          </p:cNvPr>
          <p:cNvSpPr txBox="1"/>
          <p:nvPr/>
        </p:nvSpPr>
        <p:spPr>
          <a:xfrm>
            <a:off x="123382" y="727920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-1</a:t>
            </a:r>
            <a:endParaRPr lang="zh-CN" altLang="en-US" b="1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0EF2D1A5-1143-D4AC-7DCE-38C8123ACD1E}"/>
              </a:ext>
            </a:extLst>
          </p:cNvPr>
          <p:cNvSpPr/>
          <p:nvPr/>
        </p:nvSpPr>
        <p:spPr>
          <a:xfrm>
            <a:off x="1374588" y="1552340"/>
            <a:ext cx="2656217" cy="4258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BC420AD0-CD17-6A71-17BE-36EB6E03A37F}"/>
              </a:ext>
            </a:extLst>
          </p:cNvPr>
          <p:cNvSpPr/>
          <p:nvPr/>
        </p:nvSpPr>
        <p:spPr>
          <a:xfrm>
            <a:off x="4724400" y="1552340"/>
            <a:ext cx="2782047" cy="4258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11C2480-4578-DAC4-CB1C-E7C4438D942A}"/>
              </a:ext>
            </a:extLst>
          </p:cNvPr>
          <p:cNvSpPr txBox="1"/>
          <p:nvPr/>
        </p:nvSpPr>
        <p:spPr>
          <a:xfrm>
            <a:off x="2235074" y="2193363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LSS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41C3DB4-A83D-4AA6-C2A8-FEDC11FC539D}"/>
              </a:ext>
            </a:extLst>
          </p:cNvPr>
          <p:cNvSpPr txBox="1"/>
          <p:nvPr/>
        </p:nvSpPr>
        <p:spPr>
          <a:xfrm>
            <a:off x="5831343" y="2228285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885870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873943C-2024-6225-FB50-D4AF2601AFC9}"/>
              </a:ext>
            </a:extLst>
          </p:cNvPr>
          <p:cNvSpPr txBox="1"/>
          <p:nvPr/>
        </p:nvSpPr>
        <p:spPr>
          <a:xfrm>
            <a:off x="219252" y="125716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iginal western blot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417C3E5-6A72-F2B8-3AA6-520B187BF71D}"/>
              </a:ext>
            </a:extLst>
          </p:cNvPr>
          <p:cNvSpPr txBox="1"/>
          <p:nvPr/>
        </p:nvSpPr>
        <p:spPr>
          <a:xfrm>
            <a:off x="219252" y="527637"/>
            <a:ext cx="679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Fig-2</a:t>
            </a:r>
            <a:endParaRPr lang="zh-CN" altLang="en-US" sz="16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3991BC1-E634-D417-B394-EEB343D3E7A2}"/>
              </a:ext>
            </a:extLst>
          </p:cNvPr>
          <p:cNvSpPr txBox="1"/>
          <p:nvPr/>
        </p:nvSpPr>
        <p:spPr>
          <a:xfrm>
            <a:off x="4831583" y="2235326"/>
            <a:ext cx="16177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Fig-2A GAPDH2</a:t>
            </a:r>
            <a:endParaRPr lang="zh-CN" altLang="en-US" sz="16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CF6C3D0-22DD-ABB7-C4F2-A5F0C9945FE1}"/>
              </a:ext>
            </a:extLst>
          </p:cNvPr>
          <p:cNvSpPr txBox="1"/>
          <p:nvPr/>
        </p:nvSpPr>
        <p:spPr>
          <a:xfrm>
            <a:off x="2772343" y="5893477"/>
            <a:ext cx="12811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Fig-2F LSS 2</a:t>
            </a:r>
            <a:endParaRPr lang="zh-CN" altLang="en-US" sz="16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DE323F0-1CC8-8F1E-CA7F-F5B977ECB22A}"/>
              </a:ext>
            </a:extLst>
          </p:cNvPr>
          <p:cNvSpPr txBox="1"/>
          <p:nvPr/>
        </p:nvSpPr>
        <p:spPr>
          <a:xfrm>
            <a:off x="7769685" y="5893477"/>
            <a:ext cx="18036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Fig-2F Caspase3 2</a:t>
            </a:r>
            <a:endParaRPr lang="zh-CN" altLang="en-US" sz="1600" dirty="0"/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A7CDEA53-F839-57F7-2934-15D0E557E28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251" t="18343" r="9636" b="20139"/>
          <a:stretch/>
        </p:blipFill>
        <p:spPr>
          <a:xfrm>
            <a:off x="2607612" y="4767713"/>
            <a:ext cx="1610582" cy="112576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5C56618-804C-72D6-D58C-465A13842D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08159" y="998642"/>
            <a:ext cx="1864601" cy="115009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pSp>
        <p:nvGrpSpPr>
          <p:cNvPr id="52" name="组合 51">
            <a:extLst>
              <a:ext uri="{FF2B5EF4-FFF2-40B4-BE49-F238E27FC236}">
                <a16:creationId xmlns:a16="http://schemas.microsoft.com/office/drawing/2014/main" id="{C3BDC416-4E56-CE31-D39A-4BA68DE48086}"/>
              </a:ext>
            </a:extLst>
          </p:cNvPr>
          <p:cNvGrpSpPr/>
          <p:nvPr/>
        </p:nvGrpSpPr>
        <p:grpSpPr>
          <a:xfrm>
            <a:off x="1041117" y="1148406"/>
            <a:ext cx="1731226" cy="1460049"/>
            <a:chOff x="1082600" y="2118089"/>
            <a:chExt cx="1731226" cy="1460049"/>
          </a:xfrm>
        </p:grpSpPr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A083A1A-1033-7DBB-0EFD-53E76AB9EDDF}"/>
                </a:ext>
              </a:extLst>
            </p:cNvPr>
            <p:cNvSpPr txBox="1"/>
            <p:nvPr/>
          </p:nvSpPr>
          <p:spPr>
            <a:xfrm>
              <a:off x="1139970" y="3239584"/>
              <a:ext cx="16738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A GAPDH 1</a:t>
              </a:r>
              <a:endParaRPr lang="zh-CN" altLang="en-US" sz="1600" dirty="0"/>
            </a:p>
          </p:txBody>
        </p:sp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D4347CD5-BDDD-362B-60F8-3BAB8CEBF02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82600" y="2118089"/>
              <a:ext cx="1694780" cy="100332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74087A07-68D1-359F-28DD-86973A741104}"/>
                </a:ext>
              </a:extLst>
            </p:cNvPr>
            <p:cNvSpPr/>
            <p:nvPr/>
          </p:nvSpPr>
          <p:spPr>
            <a:xfrm>
              <a:off x="1467829" y="2430301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0EEE9CC2-9340-5A17-B269-E917EEEF712D}"/>
              </a:ext>
            </a:extLst>
          </p:cNvPr>
          <p:cNvGrpSpPr/>
          <p:nvPr/>
        </p:nvGrpSpPr>
        <p:grpSpPr>
          <a:xfrm>
            <a:off x="2922278" y="994177"/>
            <a:ext cx="1596976" cy="1579703"/>
            <a:chOff x="2989037" y="1998435"/>
            <a:chExt cx="1596976" cy="1579703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2C89D2AA-E4AB-4E06-9610-EE2926695900}"/>
                </a:ext>
              </a:extLst>
            </p:cNvPr>
            <p:cNvSpPr txBox="1"/>
            <p:nvPr/>
          </p:nvSpPr>
          <p:spPr>
            <a:xfrm>
              <a:off x="3098877" y="3239584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A LSS 1</a:t>
              </a:r>
              <a:endParaRPr lang="zh-CN" altLang="en-US" sz="1600" dirty="0"/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7C61A37D-CB4E-72D1-EE4C-30B4C930F74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89037" y="1998435"/>
              <a:ext cx="1596976" cy="121106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8CB6A2A6-7CF7-4528-D997-1D350326DD7A}"/>
                </a:ext>
              </a:extLst>
            </p:cNvPr>
            <p:cNvSpPr/>
            <p:nvPr/>
          </p:nvSpPr>
          <p:spPr>
            <a:xfrm>
              <a:off x="3240406" y="2452697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283ED8EB-9ACF-9DA2-9295-25F01396D16D}"/>
              </a:ext>
            </a:extLst>
          </p:cNvPr>
          <p:cNvSpPr txBox="1"/>
          <p:nvPr/>
        </p:nvSpPr>
        <p:spPr>
          <a:xfrm>
            <a:off x="2627271" y="4296048"/>
            <a:ext cx="12811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Fig-2F LSS 1</a:t>
            </a:r>
            <a:endParaRPr lang="zh-CN" altLang="en-US" sz="1600" dirty="0"/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75B2AB6D-FF04-A53B-3C05-2611FFFF9F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251" t="18343" r="9636" b="20139"/>
          <a:stretch/>
        </p:blipFill>
        <p:spPr>
          <a:xfrm>
            <a:off x="2490355" y="3108506"/>
            <a:ext cx="1610582" cy="112576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06579DA0-1DDF-3494-EE1B-ED956A77AA28}"/>
              </a:ext>
            </a:extLst>
          </p:cNvPr>
          <p:cNvSpPr/>
          <p:nvPr/>
        </p:nvSpPr>
        <p:spPr>
          <a:xfrm>
            <a:off x="2725734" y="3607362"/>
            <a:ext cx="512024" cy="3534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6061A517-122C-106E-CD67-4683CFAF94D0}"/>
              </a:ext>
            </a:extLst>
          </p:cNvPr>
          <p:cNvGrpSpPr/>
          <p:nvPr/>
        </p:nvGrpSpPr>
        <p:grpSpPr>
          <a:xfrm>
            <a:off x="678360" y="3237100"/>
            <a:ext cx="1700166" cy="1384504"/>
            <a:chOff x="626154" y="3938931"/>
            <a:chExt cx="1700166" cy="1384504"/>
          </a:xfrm>
        </p:grpSpPr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85FA9845-9125-2E95-BE88-B8C80CEBCB88}"/>
                </a:ext>
              </a:extLst>
            </p:cNvPr>
            <p:cNvSpPr txBox="1"/>
            <p:nvPr/>
          </p:nvSpPr>
          <p:spPr>
            <a:xfrm>
              <a:off x="790945" y="4984881"/>
              <a:ext cx="139493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F actin 1</a:t>
              </a:r>
              <a:endParaRPr lang="zh-CN" altLang="en-US" sz="1600" dirty="0"/>
            </a:p>
          </p:txBody>
        </p:sp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CE89064F-AE11-DF2E-1300-C2D8C6F539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2925" t="31492" r="7944" b="19088"/>
            <a:stretch/>
          </p:blipFill>
          <p:spPr>
            <a:xfrm>
              <a:off x="626154" y="3938931"/>
              <a:ext cx="1700166" cy="95388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0F3BB565-D4DD-AC96-8B87-C2ECF878F28E}"/>
                </a:ext>
              </a:extLst>
            </p:cNvPr>
            <p:cNvSpPr/>
            <p:nvPr/>
          </p:nvSpPr>
          <p:spPr>
            <a:xfrm>
              <a:off x="964213" y="4378378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8FC012FA-F17F-0FAA-5BA6-0D32F5AA7991}"/>
              </a:ext>
            </a:extLst>
          </p:cNvPr>
          <p:cNvGrpSpPr/>
          <p:nvPr/>
        </p:nvGrpSpPr>
        <p:grpSpPr>
          <a:xfrm>
            <a:off x="6772692" y="994177"/>
            <a:ext cx="1596976" cy="1586076"/>
            <a:chOff x="6616469" y="1938636"/>
            <a:chExt cx="1596976" cy="1586076"/>
          </a:xfrm>
        </p:grpSpPr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28BF781F-BFA5-6523-2598-1D3820F78B30}"/>
                </a:ext>
              </a:extLst>
            </p:cNvPr>
            <p:cNvSpPr txBox="1"/>
            <p:nvPr/>
          </p:nvSpPr>
          <p:spPr>
            <a:xfrm>
              <a:off x="6664344" y="3186158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A LSS 2</a:t>
              </a:r>
              <a:endParaRPr lang="zh-CN" altLang="en-US" sz="1600" dirty="0"/>
            </a:p>
          </p:txBody>
        </p:sp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F1133FDA-3A2F-0059-1AF2-4DD95ED8935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616469" y="1938636"/>
              <a:ext cx="1596976" cy="1164712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39381FED-1569-054E-C487-39E1BB880230}"/>
                </a:ext>
              </a:extLst>
            </p:cNvPr>
            <p:cNvSpPr/>
            <p:nvPr/>
          </p:nvSpPr>
          <p:spPr>
            <a:xfrm>
              <a:off x="7465500" y="2448357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sp>
        <p:nvSpPr>
          <p:cNvPr id="32" name="矩形 31">
            <a:extLst>
              <a:ext uri="{FF2B5EF4-FFF2-40B4-BE49-F238E27FC236}">
                <a16:creationId xmlns:a16="http://schemas.microsoft.com/office/drawing/2014/main" id="{60A0EE37-BD23-5C85-73F0-99EF456B0C72}"/>
              </a:ext>
            </a:extLst>
          </p:cNvPr>
          <p:cNvSpPr/>
          <p:nvPr/>
        </p:nvSpPr>
        <p:spPr>
          <a:xfrm>
            <a:off x="5699183" y="1284083"/>
            <a:ext cx="612935" cy="2374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63A1ED4D-4632-C5E7-DCC6-1E82E5EA5E07}"/>
              </a:ext>
            </a:extLst>
          </p:cNvPr>
          <p:cNvGrpSpPr/>
          <p:nvPr/>
        </p:nvGrpSpPr>
        <p:grpSpPr>
          <a:xfrm>
            <a:off x="8060805" y="2162108"/>
            <a:ext cx="1803699" cy="2411181"/>
            <a:chOff x="7464013" y="3117972"/>
            <a:chExt cx="1803699" cy="2411181"/>
          </a:xfrm>
        </p:grpSpPr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4C1DEBA0-F2D7-D2B0-ED31-AB47AD2086FD}"/>
                </a:ext>
              </a:extLst>
            </p:cNvPr>
            <p:cNvSpPr txBox="1"/>
            <p:nvPr/>
          </p:nvSpPr>
          <p:spPr>
            <a:xfrm>
              <a:off x="7464013" y="5190599"/>
              <a:ext cx="18036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F Caspase3 1</a:t>
              </a:r>
              <a:endParaRPr lang="zh-CN" altLang="en-US" sz="1600" dirty="0"/>
            </a:p>
          </p:txBody>
        </p:sp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5075416A-215F-838A-0917-98E4CE7C4ED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069019" y="3117972"/>
              <a:ext cx="1049276" cy="206188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F5A51627-90C9-AFAA-5B19-37EEF74F47B3}"/>
                </a:ext>
              </a:extLst>
            </p:cNvPr>
            <p:cNvSpPr/>
            <p:nvPr/>
          </p:nvSpPr>
          <p:spPr>
            <a:xfrm>
              <a:off x="8396329" y="4345905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DD4A2319-B0EB-D518-00EE-DEE8ACFACDAF}"/>
                </a:ext>
              </a:extLst>
            </p:cNvPr>
            <p:cNvSpPr/>
            <p:nvPr/>
          </p:nvSpPr>
          <p:spPr>
            <a:xfrm>
              <a:off x="8401214" y="3876735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7F7F2354-4C22-BDDE-1F5C-6417D38BDB8D}"/>
              </a:ext>
            </a:extLst>
          </p:cNvPr>
          <p:cNvGrpSpPr/>
          <p:nvPr/>
        </p:nvGrpSpPr>
        <p:grpSpPr>
          <a:xfrm>
            <a:off x="6188830" y="2608455"/>
            <a:ext cx="2010487" cy="1956856"/>
            <a:chOff x="5711025" y="3583041"/>
            <a:chExt cx="2010487" cy="1956856"/>
          </a:xfrm>
        </p:grpSpPr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8E884655-98DD-16E3-FE85-5394B80E14A1}"/>
                </a:ext>
              </a:extLst>
            </p:cNvPr>
            <p:cNvSpPr txBox="1"/>
            <p:nvPr/>
          </p:nvSpPr>
          <p:spPr>
            <a:xfrm>
              <a:off x="5984112" y="5201343"/>
              <a:ext cx="13388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F BAX 1</a:t>
              </a:r>
              <a:endParaRPr lang="zh-CN" altLang="en-US" sz="1600" dirty="0"/>
            </a:p>
          </p:txBody>
        </p:sp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58CD524B-B72B-0702-4310-5570C1F7578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711025" y="3583041"/>
              <a:ext cx="2010487" cy="1665665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4BCC4BA7-C815-3B9A-961F-DBD7D3E24433}"/>
                </a:ext>
              </a:extLst>
            </p:cNvPr>
            <p:cNvSpPr/>
            <p:nvPr/>
          </p:nvSpPr>
          <p:spPr>
            <a:xfrm>
              <a:off x="6817576" y="4554594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07F661F9-0A9E-F81B-EC7F-1EF264034AFB}"/>
              </a:ext>
            </a:extLst>
          </p:cNvPr>
          <p:cNvGrpSpPr/>
          <p:nvPr/>
        </p:nvGrpSpPr>
        <p:grpSpPr>
          <a:xfrm>
            <a:off x="4206305" y="2684936"/>
            <a:ext cx="1868873" cy="1932535"/>
            <a:chOff x="4134174" y="3607362"/>
            <a:chExt cx="1868873" cy="1932535"/>
          </a:xfrm>
        </p:grpSpPr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8E8B3D3-51AA-A692-1319-246350AF1D7B}"/>
                </a:ext>
              </a:extLst>
            </p:cNvPr>
            <p:cNvSpPr txBox="1"/>
            <p:nvPr/>
          </p:nvSpPr>
          <p:spPr>
            <a:xfrm>
              <a:off x="4375648" y="5201343"/>
              <a:ext cx="13115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F BCL 1</a:t>
              </a:r>
              <a:endParaRPr lang="zh-CN" altLang="en-US" sz="1600" dirty="0"/>
            </a:p>
          </p:txBody>
        </p:sp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CC6FDF2B-A8ED-421F-5353-A509B54C07A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134174" y="3607362"/>
              <a:ext cx="1868873" cy="151472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59CCA78D-6B31-D761-21D3-A9AD1C42C8B1}"/>
                </a:ext>
              </a:extLst>
            </p:cNvPr>
            <p:cNvSpPr/>
            <p:nvPr/>
          </p:nvSpPr>
          <p:spPr>
            <a:xfrm>
              <a:off x="4522872" y="4115475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93B13B96-FB69-6D62-6701-A77AE98CD41C}"/>
              </a:ext>
            </a:extLst>
          </p:cNvPr>
          <p:cNvGrpSpPr/>
          <p:nvPr/>
        </p:nvGrpSpPr>
        <p:grpSpPr>
          <a:xfrm>
            <a:off x="7771096" y="4785030"/>
            <a:ext cx="1734049" cy="1050198"/>
            <a:chOff x="9879277" y="5285656"/>
            <a:chExt cx="1734049" cy="1050198"/>
          </a:xfrm>
        </p:grpSpPr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D64F6E6E-36A9-B6BE-CA33-C61331807E2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9879277" y="5285656"/>
              <a:ext cx="1734049" cy="1050198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D2A430C9-687B-9FD7-C96F-B2AC177C0B18}"/>
                </a:ext>
              </a:extLst>
            </p:cNvPr>
            <p:cNvSpPr/>
            <p:nvPr/>
          </p:nvSpPr>
          <p:spPr>
            <a:xfrm>
              <a:off x="10236889" y="5754158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A988DE80-6847-596B-DE90-0764F858341D}"/>
                </a:ext>
              </a:extLst>
            </p:cNvPr>
            <p:cNvSpPr/>
            <p:nvPr/>
          </p:nvSpPr>
          <p:spPr>
            <a:xfrm>
              <a:off x="10191564" y="5340919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3F065F7F-E7B9-45B5-6A83-8C8AD4C3C37D}"/>
              </a:ext>
            </a:extLst>
          </p:cNvPr>
          <p:cNvGrpSpPr/>
          <p:nvPr/>
        </p:nvGrpSpPr>
        <p:grpSpPr>
          <a:xfrm>
            <a:off x="6130990" y="4699504"/>
            <a:ext cx="1338828" cy="1540326"/>
            <a:chOff x="8257961" y="5163773"/>
            <a:chExt cx="1338828" cy="1540326"/>
          </a:xfrm>
        </p:grpSpPr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CE399B73-ABEC-63EE-D46D-9675F9B9412C}"/>
                </a:ext>
              </a:extLst>
            </p:cNvPr>
            <p:cNvSpPr txBox="1"/>
            <p:nvPr/>
          </p:nvSpPr>
          <p:spPr>
            <a:xfrm>
              <a:off x="8257961" y="6365545"/>
              <a:ext cx="133882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F BAX 2</a:t>
              </a:r>
              <a:endParaRPr lang="zh-CN" altLang="en-US" sz="1600" dirty="0"/>
            </a:p>
          </p:txBody>
        </p:sp>
        <p:pic>
          <p:nvPicPr>
            <p:cNvPr id="38" name="图片 37">
              <a:extLst>
                <a:ext uri="{FF2B5EF4-FFF2-40B4-BE49-F238E27FC236}">
                  <a16:creationId xmlns:a16="http://schemas.microsoft.com/office/drawing/2014/main" id="{5AA6895A-7A21-E127-731A-39D207B283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t="26776"/>
            <a:stretch/>
          </p:blipFill>
          <p:spPr>
            <a:xfrm>
              <a:off x="8438016" y="5163773"/>
              <a:ext cx="1049276" cy="1248286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49C61E58-3491-0F11-085A-556F5A092CFA}"/>
                </a:ext>
              </a:extLst>
            </p:cNvPr>
            <p:cNvSpPr/>
            <p:nvPr/>
          </p:nvSpPr>
          <p:spPr>
            <a:xfrm>
              <a:off x="8962654" y="5850271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EBDAD003-1ED4-80F6-74EA-1676C1D992AC}"/>
              </a:ext>
            </a:extLst>
          </p:cNvPr>
          <p:cNvGrpSpPr/>
          <p:nvPr/>
        </p:nvGrpSpPr>
        <p:grpSpPr>
          <a:xfrm>
            <a:off x="4435105" y="4670515"/>
            <a:ext cx="1518501" cy="1580425"/>
            <a:chOff x="6568254" y="5098024"/>
            <a:chExt cx="1518501" cy="1580425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10F8C36D-A442-6A55-97E1-BDFC019651EA}"/>
                </a:ext>
              </a:extLst>
            </p:cNvPr>
            <p:cNvSpPr txBox="1"/>
            <p:nvPr/>
          </p:nvSpPr>
          <p:spPr>
            <a:xfrm>
              <a:off x="6652694" y="6339895"/>
              <a:ext cx="13115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F BCL 2</a:t>
              </a:r>
              <a:endParaRPr lang="zh-CN" altLang="en-US" sz="1600" dirty="0"/>
            </a:p>
          </p:txBody>
        </p:sp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FA212BA8-327E-13AE-2B3A-756C15A8510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568254" y="5098024"/>
              <a:ext cx="1518501" cy="1230749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49" name="矩形 48">
              <a:extLst>
                <a:ext uri="{FF2B5EF4-FFF2-40B4-BE49-F238E27FC236}">
                  <a16:creationId xmlns:a16="http://schemas.microsoft.com/office/drawing/2014/main" id="{3C7983B1-317E-0603-8064-9823B2DF4D06}"/>
                </a:ext>
              </a:extLst>
            </p:cNvPr>
            <p:cNvSpPr/>
            <p:nvPr/>
          </p:nvSpPr>
          <p:spPr>
            <a:xfrm>
              <a:off x="7288721" y="5480791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sp>
        <p:nvSpPr>
          <p:cNvPr id="50" name="矩形 49">
            <a:extLst>
              <a:ext uri="{FF2B5EF4-FFF2-40B4-BE49-F238E27FC236}">
                <a16:creationId xmlns:a16="http://schemas.microsoft.com/office/drawing/2014/main" id="{01057F7F-5631-4CF0-8861-917C5B0DA78B}"/>
              </a:ext>
            </a:extLst>
          </p:cNvPr>
          <p:cNvSpPr/>
          <p:nvPr/>
        </p:nvSpPr>
        <p:spPr>
          <a:xfrm>
            <a:off x="3387498" y="5325334"/>
            <a:ext cx="512024" cy="3225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grpSp>
        <p:nvGrpSpPr>
          <p:cNvPr id="60" name="组合 59">
            <a:extLst>
              <a:ext uri="{FF2B5EF4-FFF2-40B4-BE49-F238E27FC236}">
                <a16:creationId xmlns:a16="http://schemas.microsoft.com/office/drawing/2014/main" id="{FBB0A3C9-2845-90CC-2143-41363335EF75}"/>
              </a:ext>
            </a:extLst>
          </p:cNvPr>
          <p:cNvGrpSpPr/>
          <p:nvPr/>
        </p:nvGrpSpPr>
        <p:grpSpPr>
          <a:xfrm>
            <a:off x="690535" y="4913941"/>
            <a:ext cx="1700166" cy="1325026"/>
            <a:chOff x="3245939" y="5394462"/>
            <a:chExt cx="1700166" cy="1325026"/>
          </a:xfrm>
        </p:grpSpPr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82F9D2A7-705F-D1F8-3F5C-9E04944EF38E}"/>
                </a:ext>
              </a:extLst>
            </p:cNvPr>
            <p:cNvSpPr txBox="1"/>
            <p:nvPr/>
          </p:nvSpPr>
          <p:spPr>
            <a:xfrm>
              <a:off x="3381392" y="6380934"/>
              <a:ext cx="139493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/>
                <a:t>Fig-2F actin 2</a:t>
              </a:r>
              <a:endParaRPr lang="zh-CN" altLang="en-US" sz="1600" dirty="0"/>
            </a:p>
          </p:txBody>
        </p:sp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517D4E0D-90CF-5120-BBB2-004753A46F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2925" t="31492" r="7944" b="19088"/>
            <a:stretch/>
          </p:blipFill>
          <p:spPr>
            <a:xfrm>
              <a:off x="3245939" y="5394462"/>
              <a:ext cx="1700166" cy="95388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E9759D51-19B7-ADDA-7D17-5B63D59C4E66}"/>
                </a:ext>
              </a:extLst>
            </p:cNvPr>
            <p:cNvSpPr/>
            <p:nvPr/>
          </p:nvSpPr>
          <p:spPr>
            <a:xfrm>
              <a:off x="4128002" y="5820273"/>
              <a:ext cx="512024" cy="1670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</p:spTree>
    <p:extLst>
      <p:ext uri="{BB962C8B-B14F-4D97-AF65-F5344CB8AC3E}">
        <p14:creationId xmlns:p14="http://schemas.microsoft.com/office/powerpoint/2010/main" val="15407627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873943C-2024-6225-FB50-D4AF2601AFC9}"/>
              </a:ext>
            </a:extLst>
          </p:cNvPr>
          <p:cNvSpPr txBox="1"/>
          <p:nvPr/>
        </p:nvSpPr>
        <p:spPr>
          <a:xfrm>
            <a:off x="669365" y="358588"/>
            <a:ext cx="2608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i="0" dirty="0">
                <a:solidFill>
                  <a:srgbClr val="222222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riginal western blot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417C3E5-6A72-F2B8-3AA6-520B187BF71D}"/>
              </a:ext>
            </a:extLst>
          </p:cNvPr>
          <p:cNvSpPr txBox="1"/>
          <p:nvPr/>
        </p:nvSpPr>
        <p:spPr>
          <a:xfrm>
            <a:off x="196929" y="917993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-3</a:t>
            </a:r>
            <a:endParaRPr lang="zh-CN" altLang="en-US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A083A1A-1033-7DBB-0EFD-53E76AB9EDDF}"/>
              </a:ext>
            </a:extLst>
          </p:cNvPr>
          <p:cNvSpPr txBox="1"/>
          <p:nvPr/>
        </p:nvSpPr>
        <p:spPr>
          <a:xfrm>
            <a:off x="1108391" y="1758309"/>
            <a:ext cx="1859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A GAPDH 1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3991BC1-E634-D417-B394-EEB343D3E7A2}"/>
              </a:ext>
            </a:extLst>
          </p:cNvPr>
          <p:cNvSpPr txBox="1"/>
          <p:nvPr/>
        </p:nvSpPr>
        <p:spPr>
          <a:xfrm>
            <a:off x="4594562" y="1758309"/>
            <a:ext cx="17972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A GAPDH2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8BF781F-BFA5-6523-2598-1D3820F78B30}"/>
              </a:ext>
            </a:extLst>
          </p:cNvPr>
          <p:cNvSpPr txBox="1"/>
          <p:nvPr/>
        </p:nvSpPr>
        <p:spPr>
          <a:xfrm>
            <a:off x="6524341" y="1719747"/>
            <a:ext cx="14558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2A LSS 2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C89D2AA-E4AB-4E06-9610-EE2926695900}"/>
              </a:ext>
            </a:extLst>
          </p:cNvPr>
          <p:cNvSpPr txBox="1"/>
          <p:nvPr/>
        </p:nvSpPr>
        <p:spPr>
          <a:xfrm>
            <a:off x="3138714" y="1758309"/>
            <a:ext cx="14558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A LSS 1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5FA9845-9125-2E95-BE88-B8C80CEBCB88}"/>
              </a:ext>
            </a:extLst>
          </p:cNvPr>
          <p:cNvSpPr txBox="1"/>
          <p:nvPr/>
        </p:nvSpPr>
        <p:spPr>
          <a:xfrm>
            <a:off x="941043" y="4269017"/>
            <a:ext cx="15456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actin 1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2F9D2A7-705F-D1F8-3F5C-9E04944EF38E}"/>
              </a:ext>
            </a:extLst>
          </p:cNvPr>
          <p:cNvSpPr txBox="1"/>
          <p:nvPr/>
        </p:nvSpPr>
        <p:spPr>
          <a:xfrm>
            <a:off x="3218089" y="6411578"/>
            <a:ext cx="15456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actin 2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83ED8EB-9ACF-9DA2-9295-25F01396D16D}"/>
              </a:ext>
            </a:extLst>
          </p:cNvPr>
          <p:cNvSpPr txBox="1"/>
          <p:nvPr/>
        </p:nvSpPr>
        <p:spPr>
          <a:xfrm>
            <a:off x="2800848" y="4269017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LSS 1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CF6C3D0-22DD-ABB7-C4F2-A5F0C9945FE1}"/>
              </a:ext>
            </a:extLst>
          </p:cNvPr>
          <p:cNvSpPr txBox="1"/>
          <p:nvPr/>
        </p:nvSpPr>
        <p:spPr>
          <a:xfrm>
            <a:off x="5081091" y="6334454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LSS 2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8E8B3D3-51AA-A692-1319-246350AF1D7B}"/>
              </a:ext>
            </a:extLst>
          </p:cNvPr>
          <p:cNvSpPr txBox="1"/>
          <p:nvPr/>
        </p:nvSpPr>
        <p:spPr>
          <a:xfrm>
            <a:off x="4375648" y="4269017"/>
            <a:ext cx="1452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BCL 1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0F8C36D-A442-6A55-97E1-BDFC019651EA}"/>
              </a:ext>
            </a:extLst>
          </p:cNvPr>
          <p:cNvSpPr txBox="1"/>
          <p:nvPr/>
        </p:nvSpPr>
        <p:spPr>
          <a:xfrm>
            <a:off x="6652694" y="6339895"/>
            <a:ext cx="1452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BCL 2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E884655-98DD-16E3-FE85-5394B80E14A1}"/>
              </a:ext>
            </a:extLst>
          </p:cNvPr>
          <p:cNvSpPr txBox="1"/>
          <p:nvPr/>
        </p:nvSpPr>
        <p:spPr>
          <a:xfrm>
            <a:off x="5984112" y="4269017"/>
            <a:ext cx="1483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BAX 1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E399B73-ABEC-63EE-D46D-9675F9B9412C}"/>
              </a:ext>
            </a:extLst>
          </p:cNvPr>
          <p:cNvSpPr txBox="1"/>
          <p:nvPr/>
        </p:nvSpPr>
        <p:spPr>
          <a:xfrm>
            <a:off x="8257961" y="6365545"/>
            <a:ext cx="1483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BAX 2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C1DEBA0-F2D7-D2B0-ED31-AB47AD2086FD}"/>
              </a:ext>
            </a:extLst>
          </p:cNvPr>
          <p:cNvSpPr txBox="1"/>
          <p:nvPr/>
        </p:nvSpPr>
        <p:spPr>
          <a:xfrm>
            <a:off x="7464013" y="4258273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Caspase3 1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DE323F0-1CC8-8F1E-CA7F-F5B977ECB22A}"/>
              </a:ext>
            </a:extLst>
          </p:cNvPr>
          <p:cNvSpPr txBox="1"/>
          <p:nvPr/>
        </p:nvSpPr>
        <p:spPr>
          <a:xfrm>
            <a:off x="9741059" y="6334454"/>
            <a:ext cx="201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-3F Caspase3 2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3B16DDEF-44DC-8D25-A56C-D4A850BC33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63619" y="2155064"/>
            <a:ext cx="922851" cy="199912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37536ACA-9889-EA0F-5F84-AF39747A89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93211" y="2112772"/>
            <a:ext cx="1339616" cy="200203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CFC83C3-33BC-BC65-120D-859D9D27A8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08533" y="2112772"/>
            <a:ext cx="1299717" cy="200203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9F4D0D0-561A-9084-2210-1DF5880393D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677408" y="4901518"/>
            <a:ext cx="2137788" cy="129471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0FCA9B3-20EE-CF9C-C493-D5C2DB34FC9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71650" y="4885786"/>
            <a:ext cx="1581005" cy="144336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DDA1C23-AEF2-0A01-1EAE-586961BB2C6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97663" y="638614"/>
            <a:ext cx="1529630" cy="115999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421CB13F-DF29-C49F-B7A9-63B2F2E8E3D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51852" y="772773"/>
            <a:ext cx="1706387" cy="85991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B94D972F-B41B-1CF5-FFD2-05B0A676317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33260" b="23186"/>
          <a:stretch/>
        </p:blipFill>
        <p:spPr>
          <a:xfrm flipV="1">
            <a:off x="4791829" y="880763"/>
            <a:ext cx="1608592" cy="69185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1639063F-A71F-6C54-CCBC-098580572ED1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23996"/>
          <a:stretch/>
        </p:blipFill>
        <p:spPr>
          <a:xfrm>
            <a:off x="5126264" y="5009301"/>
            <a:ext cx="985401" cy="124687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27DC1641-74A9-908A-E9FF-EDD6F4522C5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34185" y="3186119"/>
            <a:ext cx="1694779" cy="104535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78C7EB88-F86E-FED2-A11A-8FD825FEBD5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44580" y="2989481"/>
            <a:ext cx="1596976" cy="116471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804F71A8-ECFD-7920-636A-14D62D7EF2E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256086" y="1000968"/>
            <a:ext cx="1776844" cy="51238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21048E53-DC1D-B26F-BDAE-9F1959758C4D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336963" y="4980709"/>
            <a:ext cx="1251849" cy="1256468"/>
          </a:xfrm>
          <a:prstGeom prst="rect">
            <a:avLst/>
          </a:prstGeom>
          <a:ln w="19050">
            <a:solidFill>
              <a:srgbClr val="FFFFFF"/>
            </a:solidFill>
          </a:ln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EFBBBDAF-847B-E213-143D-379FC6B15398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00848" y="5336004"/>
            <a:ext cx="2100118" cy="7870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499E2BE6-2EAD-5380-F6B8-FB32DED7376D}"/>
              </a:ext>
            </a:extLst>
          </p:cNvPr>
          <p:cNvSpPr/>
          <p:nvPr/>
        </p:nvSpPr>
        <p:spPr>
          <a:xfrm>
            <a:off x="2183532" y="1195828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B81A09DE-FEC9-5972-E3C0-1FEB728575FC}"/>
              </a:ext>
            </a:extLst>
          </p:cNvPr>
          <p:cNvSpPr/>
          <p:nvPr/>
        </p:nvSpPr>
        <p:spPr>
          <a:xfrm>
            <a:off x="3756361" y="1060654"/>
            <a:ext cx="450185" cy="2363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05897866-6CA8-5569-4000-D544CF8949DD}"/>
              </a:ext>
            </a:extLst>
          </p:cNvPr>
          <p:cNvSpPr/>
          <p:nvPr/>
        </p:nvSpPr>
        <p:spPr>
          <a:xfrm>
            <a:off x="1393996" y="1222987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93508480-DB7D-9682-D39D-754F095DBE16}"/>
              </a:ext>
            </a:extLst>
          </p:cNvPr>
          <p:cNvSpPr/>
          <p:nvPr/>
        </p:nvSpPr>
        <p:spPr>
          <a:xfrm>
            <a:off x="5460924" y="1179834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3BD9B819-A752-84DC-7406-204FEF780D8D}"/>
              </a:ext>
            </a:extLst>
          </p:cNvPr>
          <p:cNvSpPr/>
          <p:nvPr/>
        </p:nvSpPr>
        <p:spPr>
          <a:xfrm>
            <a:off x="7457764" y="1005154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E3C2B58C-D35C-58A6-CE22-AD256C017700}"/>
              </a:ext>
            </a:extLst>
          </p:cNvPr>
          <p:cNvSpPr/>
          <p:nvPr/>
        </p:nvSpPr>
        <p:spPr>
          <a:xfrm>
            <a:off x="3004399" y="3451368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0A65D218-C80A-C495-3F70-1C9F9CF91551}"/>
              </a:ext>
            </a:extLst>
          </p:cNvPr>
          <p:cNvSpPr/>
          <p:nvPr/>
        </p:nvSpPr>
        <p:spPr>
          <a:xfrm>
            <a:off x="1175321" y="3451368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CE94B10A-04A4-D9BF-FFFF-E09597F0DA5B}"/>
              </a:ext>
            </a:extLst>
          </p:cNvPr>
          <p:cNvSpPr/>
          <p:nvPr/>
        </p:nvSpPr>
        <p:spPr>
          <a:xfrm>
            <a:off x="6750990" y="3531608"/>
            <a:ext cx="535636" cy="1736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D99AAB3F-144B-9EB2-7768-4AD91AFAFFDE}"/>
              </a:ext>
            </a:extLst>
          </p:cNvPr>
          <p:cNvSpPr/>
          <p:nvPr/>
        </p:nvSpPr>
        <p:spPr>
          <a:xfrm>
            <a:off x="5048421" y="3267305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FB488158-0D4C-3CDD-C44A-B507C836E08C}"/>
              </a:ext>
            </a:extLst>
          </p:cNvPr>
          <p:cNvSpPr/>
          <p:nvPr/>
        </p:nvSpPr>
        <p:spPr>
          <a:xfrm>
            <a:off x="10149573" y="5111350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9C116B3A-B201-791E-B5AF-9F9D564F3513}"/>
              </a:ext>
            </a:extLst>
          </p:cNvPr>
          <p:cNvSpPr/>
          <p:nvPr/>
        </p:nvSpPr>
        <p:spPr>
          <a:xfrm>
            <a:off x="8220554" y="2812294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08300E17-43F0-7F39-0332-F74123F069EB}"/>
              </a:ext>
            </a:extLst>
          </p:cNvPr>
          <p:cNvSpPr/>
          <p:nvPr/>
        </p:nvSpPr>
        <p:spPr>
          <a:xfrm>
            <a:off x="8248435" y="3374954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36AAB9DC-E454-9E62-FA49-FF71B1313922}"/>
              </a:ext>
            </a:extLst>
          </p:cNvPr>
          <p:cNvSpPr/>
          <p:nvPr/>
        </p:nvSpPr>
        <p:spPr>
          <a:xfrm>
            <a:off x="4084389" y="5632143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83B91368-57D9-457A-03BE-B285113FD709}"/>
              </a:ext>
            </a:extLst>
          </p:cNvPr>
          <p:cNvSpPr/>
          <p:nvPr/>
        </p:nvSpPr>
        <p:spPr>
          <a:xfrm>
            <a:off x="5355970" y="5800050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B2AAAD69-1D76-AC4F-FCB1-2FD48337523A}"/>
              </a:ext>
            </a:extLst>
          </p:cNvPr>
          <p:cNvSpPr/>
          <p:nvPr/>
        </p:nvSpPr>
        <p:spPr>
          <a:xfrm>
            <a:off x="6699894" y="5553183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0B6AD4A7-8918-845C-F9F0-7B2CC6751AA6}"/>
              </a:ext>
            </a:extLst>
          </p:cNvPr>
          <p:cNvSpPr/>
          <p:nvPr/>
        </p:nvSpPr>
        <p:spPr>
          <a:xfrm>
            <a:off x="8637478" y="5675556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1C62C868-4C4D-3499-4FE3-46FF66E2AAA0}"/>
              </a:ext>
            </a:extLst>
          </p:cNvPr>
          <p:cNvSpPr/>
          <p:nvPr/>
        </p:nvSpPr>
        <p:spPr>
          <a:xfrm>
            <a:off x="10109559" y="5498369"/>
            <a:ext cx="606253" cy="177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</p:spTree>
    <p:extLst>
      <p:ext uri="{BB962C8B-B14F-4D97-AF65-F5344CB8AC3E}">
        <p14:creationId xmlns:p14="http://schemas.microsoft.com/office/powerpoint/2010/main" val="19517659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B15E9BC-78AD-D420-BFAA-C982C3C17C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0071" y="1518018"/>
            <a:ext cx="739776" cy="164358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D19BCE6-DB67-1F76-D9B2-2F92D39042AA}"/>
              </a:ext>
            </a:extLst>
          </p:cNvPr>
          <p:cNvSpPr txBox="1"/>
          <p:nvPr/>
        </p:nvSpPr>
        <p:spPr>
          <a:xfrm>
            <a:off x="375846" y="3281192"/>
            <a:ext cx="9813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ERK1</a:t>
            </a:r>
            <a:endParaRPr lang="zh-CN" altLang="en-US" sz="1200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06AD3168-42F3-0C53-D74C-371BA9FF8B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1986" y="1558258"/>
            <a:ext cx="648000" cy="166864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CE1E404-E910-644E-3C86-C493FA46A8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85369" y="1541280"/>
            <a:ext cx="812587" cy="166864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1E9B194E-D84A-1273-EEDC-2B075A56E05C}"/>
              </a:ext>
            </a:extLst>
          </p:cNvPr>
          <p:cNvSpPr txBox="1"/>
          <p:nvPr/>
        </p:nvSpPr>
        <p:spPr>
          <a:xfrm>
            <a:off x="2375286" y="3289656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P38-1</a:t>
            </a:r>
            <a:endParaRPr lang="zh-CN" altLang="en-US" sz="12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E018C53-B4C8-3C44-6202-BECD4D8AEE67}"/>
              </a:ext>
            </a:extLst>
          </p:cNvPr>
          <p:cNvSpPr txBox="1"/>
          <p:nvPr/>
        </p:nvSpPr>
        <p:spPr>
          <a:xfrm>
            <a:off x="3348360" y="3334986"/>
            <a:ext cx="1218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P-P38-1</a:t>
            </a:r>
            <a:endParaRPr lang="zh-CN" altLang="en-US" sz="1200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54B4DA8F-7C3B-FB07-723C-7690410AA9D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78811" y="1521032"/>
            <a:ext cx="739777" cy="166864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97323BB1-22E6-411E-6E27-914505E4DAEA}"/>
              </a:ext>
            </a:extLst>
          </p:cNvPr>
          <p:cNvSpPr txBox="1"/>
          <p:nvPr/>
        </p:nvSpPr>
        <p:spPr>
          <a:xfrm>
            <a:off x="1306420" y="3281192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P-ERK1</a:t>
            </a:r>
            <a:endParaRPr lang="zh-CN" altLang="en-US" sz="12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63AEA2E-4588-66A5-A86D-0345D42C5477}"/>
              </a:ext>
            </a:extLst>
          </p:cNvPr>
          <p:cNvSpPr txBox="1"/>
          <p:nvPr/>
        </p:nvSpPr>
        <p:spPr>
          <a:xfrm>
            <a:off x="7140953" y="3293948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β-actin 1</a:t>
            </a:r>
            <a:endParaRPr lang="zh-CN" altLang="en-US" sz="12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1C14945-1EF5-5264-6DA8-4C0A32F98C1E}"/>
              </a:ext>
            </a:extLst>
          </p:cNvPr>
          <p:cNvSpPr txBox="1"/>
          <p:nvPr/>
        </p:nvSpPr>
        <p:spPr>
          <a:xfrm>
            <a:off x="7057440" y="5554197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β-actin 2</a:t>
            </a:r>
            <a:endParaRPr lang="zh-CN" altLang="en-US" sz="1200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9CDC038-97A9-CFAD-008D-08041BB561B2}"/>
              </a:ext>
            </a:extLst>
          </p:cNvPr>
          <p:cNvSpPr txBox="1"/>
          <p:nvPr/>
        </p:nvSpPr>
        <p:spPr>
          <a:xfrm>
            <a:off x="325061" y="5451613"/>
            <a:ext cx="9813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ERK2</a:t>
            </a:r>
            <a:endParaRPr lang="zh-CN" altLang="en-US" sz="12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3F89F643-A60B-A218-A7D8-F1DD8FCA1784}"/>
              </a:ext>
            </a:extLst>
          </p:cNvPr>
          <p:cNvSpPr txBox="1"/>
          <p:nvPr/>
        </p:nvSpPr>
        <p:spPr>
          <a:xfrm>
            <a:off x="4630155" y="3305869"/>
            <a:ext cx="10583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JNK-1</a:t>
            </a:r>
            <a:endParaRPr lang="zh-CN" altLang="en-US" sz="12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24EE4C0-5FCF-0E12-BFB8-742BB45CD86E}"/>
              </a:ext>
            </a:extLst>
          </p:cNvPr>
          <p:cNvSpPr txBox="1"/>
          <p:nvPr/>
        </p:nvSpPr>
        <p:spPr>
          <a:xfrm>
            <a:off x="5717198" y="3289655"/>
            <a:ext cx="1220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P-JNK-1</a:t>
            </a:r>
            <a:endParaRPr lang="zh-CN" altLang="en-US" sz="12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23112BA-EE57-DF67-EEA0-F6591CDA185F}"/>
              </a:ext>
            </a:extLst>
          </p:cNvPr>
          <p:cNvSpPr txBox="1"/>
          <p:nvPr/>
        </p:nvSpPr>
        <p:spPr>
          <a:xfrm>
            <a:off x="2288706" y="5451838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P38-2</a:t>
            </a:r>
            <a:endParaRPr lang="zh-CN" altLang="en-US" sz="12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02403DF-910F-1EFB-2D4D-9C5FE767FD0C}"/>
              </a:ext>
            </a:extLst>
          </p:cNvPr>
          <p:cNvSpPr txBox="1"/>
          <p:nvPr/>
        </p:nvSpPr>
        <p:spPr>
          <a:xfrm>
            <a:off x="3261780" y="5497168"/>
            <a:ext cx="1218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P-P38-2</a:t>
            </a:r>
            <a:endParaRPr lang="zh-CN" altLang="en-US" sz="12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8C9CAD74-0459-956A-4893-41058716B46A}"/>
              </a:ext>
            </a:extLst>
          </p:cNvPr>
          <p:cNvSpPr txBox="1"/>
          <p:nvPr/>
        </p:nvSpPr>
        <p:spPr>
          <a:xfrm>
            <a:off x="1219840" y="5443374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P-ERK2</a:t>
            </a:r>
            <a:endParaRPr lang="zh-CN" altLang="en-US" sz="12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7F8B35C-D930-2C24-A983-69C68398190F}"/>
              </a:ext>
            </a:extLst>
          </p:cNvPr>
          <p:cNvSpPr txBox="1"/>
          <p:nvPr/>
        </p:nvSpPr>
        <p:spPr>
          <a:xfrm>
            <a:off x="4543575" y="5468051"/>
            <a:ext cx="10583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JNK-2</a:t>
            </a:r>
            <a:endParaRPr lang="zh-CN" altLang="en-US" sz="12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986658E2-211F-D40A-02AD-A64836857FC2}"/>
              </a:ext>
            </a:extLst>
          </p:cNvPr>
          <p:cNvSpPr txBox="1"/>
          <p:nvPr/>
        </p:nvSpPr>
        <p:spPr>
          <a:xfrm>
            <a:off x="5630618" y="5451837"/>
            <a:ext cx="1220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P-JNK-2</a:t>
            </a:r>
            <a:endParaRPr lang="zh-CN" altLang="en-US" sz="1200" dirty="0"/>
          </a:p>
        </p:txBody>
      </p:sp>
      <p:pic>
        <p:nvPicPr>
          <p:cNvPr id="51" name="图片 50">
            <a:extLst>
              <a:ext uri="{FF2B5EF4-FFF2-40B4-BE49-F238E27FC236}">
                <a16:creationId xmlns:a16="http://schemas.microsoft.com/office/drawing/2014/main" id="{16D6C5AF-EB94-15CB-9E94-9BA8E47420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76427" y="3699637"/>
            <a:ext cx="992597" cy="168524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97EBC241-C80E-40F2-10B9-CBC362A9EDE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96189" y="3699637"/>
            <a:ext cx="992597" cy="162689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A9ED3957-30A0-7658-6B5C-F4293076EDC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08080" y="3746157"/>
            <a:ext cx="1034167" cy="162138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234FE924-3F4B-337F-F00A-399EF7E22AE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41067" y="3756907"/>
            <a:ext cx="981359" cy="160068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BDBDBBB3-8426-D82A-3AF3-94D3AF83683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80328" y="1486428"/>
            <a:ext cx="1002236" cy="173785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31308019-B7F7-B21E-321C-61224314138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45309" y="1541280"/>
            <a:ext cx="857200" cy="173991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36980053-D956-4C45-E53B-D4119232594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61746" y="3873818"/>
            <a:ext cx="1158849" cy="160068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09236A74-D394-BE30-A5E7-066F18F7ACDD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755986" y="3824636"/>
            <a:ext cx="701598" cy="150189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899D4356-3AF1-1EDF-98D8-E57684D71B3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010919" y="3793695"/>
            <a:ext cx="1505923" cy="170347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pSp>
        <p:nvGrpSpPr>
          <p:cNvPr id="66" name="组合 65">
            <a:extLst>
              <a:ext uri="{FF2B5EF4-FFF2-40B4-BE49-F238E27FC236}">
                <a16:creationId xmlns:a16="http://schemas.microsoft.com/office/drawing/2014/main" id="{6ABC7064-3B7D-F3C4-4477-5E29AC7EF459}"/>
              </a:ext>
            </a:extLst>
          </p:cNvPr>
          <p:cNvGrpSpPr/>
          <p:nvPr/>
        </p:nvGrpSpPr>
        <p:grpSpPr>
          <a:xfrm>
            <a:off x="8769358" y="3953904"/>
            <a:ext cx="2398040" cy="1243356"/>
            <a:chOff x="2817056" y="5553089"/>
            <a:chExt cx="2398040" cy="1243356"/>
          </a:xfrm>
        </p:grpSpPr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B20748CA-A282-61A6-DFC1-4EBC017745AC}"/>
                </a:ext>
              </a:extLst>
            </p:cNvPr>
            <p:cNvSpPr txBox="1"/>
            <p:nvPr/>
          </p:nvSpPr>
          <p:spPr>
            <a:xfrm>
              <a:off x="3020864" y="6519446"/>
              <a:ext cx="1245854" cy="27699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Fig 4G β-actin 2</a:t>
              </a:r>
              <a:endParaRPr lang="zh-CN" altLang="en-US" sz="1200" dirty="0"/>
            </a:p>
          </p:txBody>
        </p:sp>
        <p:grpSp>
          <p:nvGrpSpPr>
            <p:cNvPr id="68" name="组合 67">
              <a:extLst>
                <a:ext uri="{FF2B5EF4-FFF2-40B4-BE49-F238E27FC236}">
                  <a16:creationId xmlns:a16="http://schemas.microsoft.com/office/drawing/2014/main" id="{C315A0AE-B4D5-D007-EEF7-10046C98363C}"/>
                </a:ext>
              </a:extLst>
            </p:cNvPr>
            <p:cNvGrpSpPr/>
            <p:nvPr/>
          </p:nvGrpSpPr>
          <p:grpSpPr>
            <a:xfrm>
              <a:off x="2817056" y="5553089"/>
              <a:ext cx="2398040" cy="855771"/>
              <a:chOff x="7144676" y="5555591"/>
              <a:chExt cx="2398040" cy="855771"/>
            </a:xfrm>
          </p:grpSpPr>
          <p:pic>
            <p:nvPicPr>
              <p:cNvPr id="69" name="图片 68">
                <a:extLst>
                  <a:ext uri="{FF2B5EF4-FFF2-40B4-BE49-F238E27FC236}">
                    <a16:creationId xmlns:a16="http://schemas.microsoft.com/office/drawing/2014/main" id="{C69F1E12-9F9D-7407-3D0C-E4370AE60D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7144676" y="5555591"/>
                <a:ext cx="2398040" cy="855771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70" name="矩形 69">
                <a:extLst>
                  <a:ext uri="{FF2B5EF4-FFF2-40B4-BE49-F238E27FC236}">
                    <a16:creationId xmlns:a16="http://schemas.microsoft.com/office/drawing/2014/main" id="{6C86DA55-3F6D-A483-7573-F30E9657EF12}"/>
                  </a:ext>
                </a:extLst>
              </p:cNvPr>
              <p:cNvSpPr/>
              <p:nvPr/>
            </p:nvSpPr>
            <p:spPr>
              <a:xfrm>
                <a:off x="8704391" y="5894323"/>
                <a:ext cx="561341" cy="24798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</p:grpSp>
      </p:grpSp>
      <p:sp>
        <p:nvSpPr>
          <p:cNvPr id="71" name="矩形 70">
            <a:extLst>
              <a:ext uri="{FF2B5EF4-FFF2-40B4-BE49-F238E27FC236}">
                <a16:creationId xmlns:a16="http://schemas.microsoft.com/office/drawing/2014/main" id="{98E3C555-5FA6-240A-592C-7BA98E26A080}"/>
              </a:ext>
            </a:extLst>
          </p:cNvPr>
          <p:cNvSpPr/>
          <p:nvPr/>
        </p:nvSpPr>
        <p:spPr>
          <a:xfrm>
            <a:off x="7380941" y="4739339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C7AFEB05-6ABD-2607-3548-60C9204C725A}"/>
              </a:ext>
            </a:extLst>
          </p:cNvPr>
          <p:cNvSpPr/>
          <p:nvPr/>
        </p:nvSpPr>
        <p:spPr>
          <a:xfrm>
            <a:off x="7868532" y="4743955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BE87C096-652C-33AB-C560-BA86C51B0D4B}"/>
              </a:ext>
            </a:extLst>
          </p:cNvPr>
          <p:cNvSpPr/>
          <p:nvPr/>
        </p:nvSpPr>
        <p:spPr>
          <a:xfrm>
            <a:off x="5849496" y="4476076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D2B729D0-4FA8-BA5F-B81C-74BC4E593193}"/>
              </a:ext>
            </a:extLst>
          </p:cNvPr>
          <p:cNvSpPr/>
          <p:nvPr/>
        </p:nvSpPr>
        <p:spPr>
          <a:xfrm>
            <a:off x="4687998" y="4429931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F2FAE82D-A0C0-96C3-2806-6A5EB2A89185}"/>
              </a:ext>
            </a:extLst>
          </p:cNvPr>
          <p:cNvSpPr/>
          <p:nvPr/>
        </p:nvSpPr>
        <p:spPr>
          <a:xfrm>
            <a:off x="3903834" y="4646976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51224DE5-CEF3-0AFF-92AF-990502940A4A}"/>
              </a:ext>
            </a:extLst>
          </p:cNvPr>
          <p:cNvSpPr/>
          <p:nvPr/>
        </p:nvSpPr>
        <p:spPr>
          <a:xfrm>
            <a:off x="3060386" y="4666376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771C7A57-A240-1978-0CB5-8F8566877770}"/>
              </a:ext>
            </a:extLst>
          </p:cNvPr>
          <p:cNvSpPr/>
          <p:nvPr/>
        </p:nvSpPr>
        <p:spPr>
          <a:xfrm>
            <a:off x="1760339" y="4567657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id="{3366CC1A-5250-237A-A211-FCA20232FD46}"/>
              </a:ext>
            </a:extLst>
          </p:cNvPr>
          <p:cNvSpPr/>
          <p:nvPr/>
        </p:nvSpPr>
        <p:spPr>
          <a:xfrm>
            <a:off x="540326" y="4500843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pic>
        <p:nvPicPr>
          <p:cNvPr id="82" name="图片 81">
            <a:extLst>
              <a:ext uri="{FF2B5EF4-FFF2-40B4-BE49-F238E27FC236}">
                <a16:creationId xmlns:a16="http://schemas.microsoft.com/office/drawing/2014/main" id="{44FBA7D0-87A5-3C96-130F-FC23E4AB68C9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094373" y="2043576"/>
            <a:ext cx="1652898" cy="102762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B35BA4C2-2A3F-8514-E724-EA7932866B35}"/>
              </a:ext>
            </a:extLst>
          </p:cNvPr>
          <p:cNvSpPr/>
          <p:nvPr/>
        </p:nvSpPr>
        <p:spPr>
          <a:xfrm>
            <a:off x="727637" y="2366139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15F888EC-CDFA-70D0-A0EB-DCCA2E385593}"/>
              </a:ext>
            </a:extLst>
          </p:cNvPr>
          <p:cNvSpPr/>
          <p:nvPr/>
        </p:nvSpPr>
        <p:spPr>
          <a:xfrm>
            <a:off x="2719707" y="2392580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AB2801D1-F7D4-76D6-81F4-B499D0D7E613}"/>
              </a:ext>
            </a:extLst>
          </p:cNvPr>
          <p:cNvSpPr/>
          <p:nvPr/>
        </p:nvSpPr>
        <p:spPr>
          <a:xfrm>
            <a:off x="3559145" y="2440313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246ABC7D-A8D7-EBB3-A495-5224793481EF}"/>
              </a:ext>
            </a:extLst>
          </p:cNvPr>
          <p:cNvSpPr/>
          <p:nvPr/>
        </p:nvSpPr>
        <p:spPr>
          <a:xfrm>
            <a:off x="7445462" y="2366139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E3667566-374F-14DA-5EFE-00E6FBA18F31}"/>
              </a:ext>
            </a:extLst>
          </p:cNvPr>
          <p:cNvSpPr/>
          <p:nvPr/>
        </p:nvSpPr>
        <p:spPr>
          <a:xfrm>
            <a:off x="6003041" y="2343149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077CE04A-6463-DABF-25D1-D5EED5209C85}"/>
              </a:ext>
            </a:extLst>
          </p:cNvPr>
          <p:cNvSpPr/>
          <p:nvPr/>
        </p:nvSpPr>
        <p:spPr>
          <a:xfrm>
            <a:off x="4725599" y="2335328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B06A7388-42C1-9CA1-A62B-E9477CCD01FA}"/>
              </a:ext>
            </a:extLst>
          </p:cNvPr>
          <p:cNvSpPr/>
          <p:nvPr/>
        </p:nvSpPr>
        <p:spPr>
          <a:xfrm>
            <a:off x="1687914" y="2411236"/>
            <a:ext cx="475360" cy="1943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608CE1E-551C-C1D1-3FFE-FB346DF5D290}"/>
              </a:ext>
            </a:extLst>
          </p:cNvPr>
          <p:cNvSpPr txBox="1"/>
          <p:nvPr/>
        </p:nvSpPr>
        <p:spPr>
          <a:xfrm>
            <a:off x="196929" y="917993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-4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3863342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D19BCE6-DB67-1F76-D9B2-2F92D39042AA}"/>
              </a:ext>
            </a:extLst>
          </p:cNvPr>
          <p:cNvSpPr txBox="1"/>
          <p:nvPr/>
        </p:nvSpPr>
        <p:spPr>
          <a:xfrm>
            <a:off x="375846" y="3346928"/>
            <a:ext cx="984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ERK1</a:t>
            </a:r>
            <a:endParaRPr lang="zh-CN" altLang="en-US" sz="12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E9B194E-D84A-1273-EEDC-2B075A56E05C}"/>
              </a:ext>
            </a:extLst>
          </p:cNvPr>
          <p:cNvSpPr txBox="1"/>
          <p:nvPr/>
        </p:nvSpPr>
        <p:spPr>
          <a:xfrm>
            <a:off x="2375286" y="3355392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P38-1</a:t>
            </a:r>
            <a:endParaRPr lang="zh-CN" altLang="en-US" sz="12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E018C53-B4C8-3C44-6202-BECD4D8AEE67}"/>
              </a:ext>
            </a:extLst>
          </p:cNvPr>
          <p:cNvSpPr txBox="1"/>
          <p:nvPr/>
        </p:nvSpPr>
        <p:spPr>
          <a:xfrm>
            <a:off x="3348360" y="3329010"/>
            <a:ext cx="1218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P-P38-1</a:t>
            </a:r>
            <a:endParaRPr lang="zh-CN" altLang="en-US" sz="12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7323BB1-22E6-411E-6E27-914505E4DAEA}"/>
              </a:ext>
            </a:extLst>
          </p:cNvPr>
          <p:cNvSpPr txBox="1"/>
          <p:nvPr/>
        </p:nvSpPr>
        <p:spPr>
          <a:xfrm>
            <a:off x="1285005" y="3346928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P-ERK1</a:t>
            </a:r>
            <a:endParaRPr lang="zh-CN" altLang="en-US" sz="1200" dirty="0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8EAFDF69-06C5-3B31-76FC-6DE2B11C62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1747" y="1563337"/>
            <a:ext cx="606959" cy="166913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9CC13FC8-B736-313C-DB03-753DAD296F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2763" y="1533592"/>
            <a:ext cx="782643" cy="170129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1B91C1B2-AE32-B2BF-7CED-8AA5CBACF3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800" y="1594137"/>
            <a:ext cx="876845" cy="166913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CAB1091A-D469-62FF-48B0-A83CF32694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8548" y="1538322"/>
            <a:ext cx="831793" cy="169656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pSp>
        <p:nvGrpSpPr>
          <p:cNvPr id="73" name="组合 72">
            <a:extLst>
              <a:ext uri="{FF2B5EF4-FFF2-40B4-BE49-F238E27FC236}">
                <a16:creationId xmlns:a16="http://schemas.microsoft.com/office/drawing/2014/main" id="{E4E8A8CF-DD56-EFCF-0B04-9C83E966C9CC}"/>
              </a:ext>
            </a:extLst>
          </p:cNvPr>
          <p:cNvGrpSpPr/>
          <p:nvPr/>
        </p:nvGrpSpPr>
        <p:grpSpPr>
          <a:xfrm>
            <a:off x="9548834" y="1994009"/>
            <a:ext cx="2398040" cy="1234323"/>
            <a:chOff x="213587" y="5553090"/>
            <a:chExt cx="2398040" cy="1234323"/>
          </a:xfrm>
        </p:grpSpPr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A63AEA2E-4588-66A5-A86D-0345D42C5477}"/>
                </a:ext>
              </a:extLst>
            </p:cNvPr>
            <p:cNvSpPr txBox="1"/>
            <p:nvPr/>
          </p:nvSpPr>
          <p:spPr>
            <a:xfrm>
              <a:off x="632197" y="6510414"/>
              <a:ext cx="1245854" cy="276999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Fig 4G β-actin 1</a:t>
              </a:r>
              <a:endParaRPr lang="zh-CN" altLang="en-US" sz="1200" dirty="0"/>
            </a:p>
          </p:txBody>
        </p: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372B906B-5E8C-D41D-89FC-F89DD126DE47}"/>
                </a:ext>
              </a:extLst>
            </p:cNvPr>
            <p:cNvGrpSpPr/>
            <p:nvPr/>
          </p:nvGrpSpPr>
          <p:grpSpPr>
            <a:xfrm>
              <a:off x="213587" y="5553090"/>
              <a:ext cx="2398040" cy="855771"/>
              <a:chOff x="2812123" y="5555592"/>
              <a:chExt cx="2398040" cy="855771"/>
            </a:xfrm>
          </p:grpSpPr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77C6EC84-81B2-B186-3263-2E0A92ED71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812123" y="5555592"/>
                <a:ext cx="2398040" cy="855771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F1E016E4-DE24-2624-535C-36CA164C2975}"/>
                  </a:ext>
                </a:extLst>
              </p:cNvPr>
              <p:cNvSpPr/>
              <p:nvPr/>
            </p:nvSpPr>
            <p:spPr>
              <a:xfrm>
                <a:off x="3030518" y="5871920"/>
                <a:ext cx="561341" cy="24798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</p:grp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id="{E14B051B-2241-C5B2-CE27-EE963B449CAF}"/>
              </a:ext>
            </a:extLst>
          </p:cNvPr>
          <p:cNvGrpSpPr/>
          <p:nvPr/>
        </p:nvGrpSpPr>
        <p:grpSpPr>
          <a:xfrm>
            <a:off x="7412699" y="4325300"/>
            <a:ext cx="2398040" cy="1243356"/>
            <a:chOff x="2817056" y="5553089"/>
            <a:chExt cx="2398040" cy="1243356"/>
          </a:xfrm>
        </p:grpSpPr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D1C14945-1EF5-5264-6DA8-4C0A32F98C1E}"/>
                </a:ext>
              </a:extLst>
            </p:cNvPr>
            <p:cNvSpPr txBox="1"/>
            <p:nvPr/>
          </p:nvSpPr>
          <p:spPr>
            <a:xfrm>
              <a:off x="3020864" y="6519446"/>
              <a:ext cx="1245854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Fig 4G β-actin 2</a:t>
              </a:r>
              <a:endParaRPr lang="zh-CN" altLang="en-US" sz="1200" dirty="0"/>
            </a:p>
          </p:txBody>
        </p:sp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C77DF7DB-BDFF-E2ED-ED64-ACB059B00A31}"/>
                </a:ext>
              </a:extLst>
            </p:cNvPr>
            <p:cNvGrpSpPr/>
            <p:nvPr/>
          </p:nvGrpSpPr>
          <p:grpSpPr>
            <a:xfrm>
              <a:off x="2817056" y="5553089"/>
              <a:ext cx="2398040" cy="855771"/>
              <a:chOff x="7144676" y="5555591"/>
              <a:chExt cx="2398040" cy="855771"/>
            </a:xfrm>
          </p:grpSpPr>
          <p:pic>
            <p:nvPicPr>
              <p:cNvPr id="38" name="图片 37">
                <a:extLst>
                  <a:ext uri="{FF2B5EF4-FFF2-40B4-BE49-F238E27FC236}">
                    <a16:creationId xmlns:a16="http://schemas.microsoft.com/office/drawing/2014/main" id="{A92F8A3C-2F02-F3C0-882B-234E6636B0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7144676" y="5555591"/>
                <a:ext cx="2398040" cy="855771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id="{878EDA9B-07C4-8D49-20AC-9FC724743F25}"/>
                  </a:ext>
                </a:extLst>
              </p:cNvPr>
              <p:cNvSpPr/>
              <p:nvPr/>
            </p:nvSpPr>
            <p:spPr>
              <a:xfrm>
                <a:off x="7897567" y="5880403"/>
                <a:ext cx="561341" cy="24798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</p:grpSp>
      </p:grpSp>
      <p:sp>
        <p:nvSpPr>
          <p:cNvPr id="41" name="文本框 40">
            <a:extLst>
              <a:ext uri="{FF2B5EF4-FFF2-40B4-BE49-F238E27FC236}">
                <a16:creationId xmlns:a16="http://schemas.microsoft.com/office/drawing/2014/main" id="{D9CDC038-97A9-CFAD-008D-08041BB561B2}"/>
              </a:ext>
            </a:extLst>
          </p:cNvPr>
          <p:cNvSpPr txBox="1"/>
          <p:nvPr/>
        </p:nvSpPr>
        <p:spPr>
          <a:xfrm>
            <a:off x="325061" y="5517349"/>
            <a:ext cx="9813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ERK2</a:t>
            </a:r>
            <a:endParaRPr lang="zh-CN" altLang="en-US" sz="12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3F89F643-A60B-A218-A7D8-F1DD8FCA1784}"/>
              </a:ext>
            </a:extLst>
          </p:cNvPr>
          <p:cNvSpPr txBox="1"/>
          <p:nvPr/>
        </p:nvSpPr>
        <p:spPr>
          <a:xfrm>
            <a:off x="4612929" y="3329010"/>
            <a:ext cx="10583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JNK-1</a:t>
            </a:r>
            <a:endParaRPr lang="zh-CN" altLang="en-US" sz="12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24EE4C0-5FCF-0E12-BFB8-742BB45CD86E}"/>
              </a:ext>
            </a:extLst>
          </p:cNvPr>
          <p:cNvSpPr txBox="1"/>
          <p:nvPr/>
        </p:nvSpPr>
        <p:spPr>
          <a:xfrm>
            <a:off x="5671232" y="3324226"/>
            <a:ext cx="1220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P-JNK-1</a:t>
            </a:r>
            <a:endParaRPr lang="zh-CN" altLang="en-US" sz="12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23112BA-EE57-DF67-EEA0-F6591CDA185F}"/>
              </a:ext>
            </a:extLst>
          </p:cNvPr>
          <p:cNvSpPr txBox="1"/>
          <p:nvPr/>
        </p:nvSpPr>
        <p:spPr>
          <a:xfrm>
            <a:off x="2288706" y="5517574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P38-2</a:t>
            </a:r>
            <a:endParaRPr lang="zh-CN" altLang="en-US" sz="12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02403DF-910F-1EFB-2D4D-9C5FE767FD0C}"/>
              </a:ext>
            </a:extLst>
          </p:cNvPr>
          <p:cNvSpPr txBox="1"/>
          <p:nvPr/>
        </p:nvSpPr>
        <p:spPr>
          <a:xfrm>
            <a:off x="3261780" y="5562904"/>
            <a:ext cx="12186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P-P38-2</a:t>
            </a:r>
            <a:endParaRPr lang="zh-CN" altLang="en-US" sz="12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8C9CAD74-0459-956A-4893-41058716B46A}"/>
              </a:ext>
            </a:extLst>
          </p:cNvPr>
          <p:cNvSpPr txBox="1"/>
          <p:nvPr/>
        </p:nvSpPr>
        <p:spPr>
          <a:xfrm>
            <a:off x="1219840" y="5509110"/>
            <a:ext cx="1143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P-ERK2</a:t>
            </a:r>
            <a:endParaRPr lang="zh-CN" altLang="en-US" sz="12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7F8B35C-D930-2C24-A983-69C68398190F}"/>
              </a:ext>
            </a:extLst>
          </p:cNvPr>
          <p:cNvSpPr txBox="1"/>
          <p:nvPr/>
        </p:nvSpPr>
        <p:spPr>
          <a:xfrm>
            <a:off x="4543575" y="5533787"/>
            <a:ext cx="10583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JNK-2</a:t>
            </a:r>
            <a:endParaRPr lang="zh-CN" altLang="en-US" sz="12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986658E2-211F-D40A-02AD-A64836857FC2}"/>
              </a:ext>
            </a:extLst>
          </p:cNvPr>
          <p:cNvSpPr txBox="1"/>
          <p:nvPr/>
        </p:nvSpPr>
        <p:spPr>
          <a:xfrm>
            <a:off x="5630618" y="5517573"/>
            <a:ext cx="1220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H P-JNK-2</a:t>
            </a:r>
            <a:endParaRPr lang="zh-CN" altLang="en-US" sz="1200" dirty="0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FA28296B-AA6A-84A9-3427-C033BD88F8D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4493" y="3791235"/>
            <a:ext cx="850482" cy="156795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5ABCF800-F37F-ED02-F7E3-66D0948B1B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238052" y="3820640"/>
            <a:ext cx="923613" cy="161762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BA21F09B-25C5-C1A0-D59E-D0DF740D5F4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94671" y="3820640"/>
            <a:ext cx="950735" cy="164430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299AF318-59C9-49B1-F8C1-B4A8C97F84D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65911" y="3783776"/>
            <a:ext cx="1014472" cy="164516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8B3C8804-A6E7-6FBF-DAC3-11FF6853984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332118" y="4249449"/>
            <a:ext cx="1481215" cy="106349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E9DD1B6E-A191-C481-C763-31737C33E8C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882687" y="4249449"/>
            <a:ext cx="1324784" cy="106743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F3CC1C9D-B16F-09A6-FBC7-4DC9945A99F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621249" y="1459493"/>
            <a:ext cx="1058303" cy="185068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6A95BB16-C731-54EA-3999-A5BD6487602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983317" y="1497545"/>
            <a:ext cx="1164542" cy="173078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F2585E18-C910-8322-0419-7BE38B1D6BF2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728611" y="1587280"/>
            <a:ext cx="1744094" cy="159391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9" name="文本框 58">
            <a:extLst>
              <a:ext uri="{FF2B5EF4-FFF2-40B4-BE49-F238E27FC236}">
                <a16:creationId xmlns:a16="http://schemas.microsoft.com/office/drawing/2014/main" id="{78B564FB-B723-BB89-3F2F-75C67674204D}"/>
              </a:ext>
            </a:extLst>
          </p:cNvPr>
          <p:cNvSpPr txBox="1"/>
          <p:nvPr/>
        </p:nvSpPr>
        <p:spPr>
          <a:xfrm>
            <a:off x="7949741" y="3234886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Fig 4G β-actin 1</a:t>
            </a:r>
            <a:endParaRPr lang="zh-CN" altLang="en-US" sz="1200" dirty="0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5B3BB69F-B4EE-DD2A-DEAE-DC34EB5052CD}"/>
              </a:ext>
            </a:extLst>
          </p:cNvPr>
          <p:cNvSpPr/>
          <p:nvPr/>
        </p:nvSpPr>
        <p:spPr>
          <a:xfrm>
            <a:off x="745080" y="2384240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064E8EC9-9025-5056-7231-C08B17A359F6}"/>
              </a:ext>
            </a:extLst>
          </p:cNvPr>
          <p:cNvSpPr/>
          <p:nvPr/>
        </p:nvSpPr>
        <p:spPr>
          <a:xfrm>
            <a:off x="5182692" y="2000432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276073A7-3C5B-72D9-D6B3-A39F381176C4}"/>
              </a:ext>
            </a:extLst>
          </p:cNvPr>
          <p:cNvSpPr/>
          <p:nvPr/>
        </p:nvSpPr>
        <p:spPr>
          <a:xfrm>
            <a:off x="3757004" y="2188375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A3856999-ABA6-3C10-5752-DE88E42065BB}"/>
              </a:ext>
            </a:extLst>
          </p:cNvPr>
          <p:cNvSpPr/>
          <p:nvPr/>
        </p:nvSpPr>
        <p:spPr>
          <a:xfrm>
            <a:off x="2781638" y="2217094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4" name="矩形 63">
            <a:extLst>
              <a:ext uri="{FF2B5EF4-FFF2-40B4-BE49-F238E27FC236}">
                <a16:creationId xmlns:a16="http://schemas.microsoft.com/office/drawing/2014/main" id="{03FF01E0-658B-9038-E21A-CAA80A45DF39}"/>
              </a:ext>
            </a:extLst>
          </p:cNvPr>
          <p:cNvSpPr/>
          <p:nvPr/>
        </p:nvSpPr>
        <p:spPr>
          <a:xfrm>
            <a:off x="1826712" y="2284181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D0DCF484-6560-9B0C-4F08-D6E427C4FD48}"/>
              </a:ext>
            </a:extLst>
          </p:cNvPr>
          <p:cNvSpPr/>
          <p:nvPr/>
        </p:nvSpPr>
        <p:spPr>
          <a:xfrm>
            <a:off x="6598503" y="2017467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3198831C-0E29-65EE-5592-2245DBB5B4EB}"/>
              </a:ext>
            </a:extLst>
          </p:cNvPr>
          <p:cNvSpPr/>
          <p:nvPr/>
        </p:nvSpPr>
        <p:spPr>
          <a:xfrm>
            <a:off x="5072725" y="4612713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3ADA803E-F4C4-E4E2-6A47-7527D1F083EA}"/>
              </a:ext>
            </a:extLst>
          </p:cNvPr>
          <p:cNvSpPr/>
          <p:nvPr/>
        </p:nvSpPr>
        <p:spPr>
          <a:xfrm>
            <a:off x="3897334" y="4857149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E1C12C18-9D62-E804-CC3F-B1CA922FF0B8}"/>
              </a:ext>
            </a:extLst>
          </p:cNvPr>
          <p:cNvSpPr/>
          <p:nvPr/>
        </p:nvSpPr>
        <p:spPr>
          <a:xfrm>
            <a:off x="2653895" y="4755366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69" name="矩形 68">
            <a:extLst>
              <a:ext uri="{FF2B5EF4-FFF2-40B4-BE49-F238E27FC236}">
                <a16:creationId xmlns:a16="http://schemas.microsoft.com/office/drawing/2014/main" id="{1D1CBC06-7664-6198-281F-5ED3400AEE78}"/>
              </a:ext>
            </a:extLst>
          </p:cNvPr>
          <p:cNvSpPr/>
          <p:nvPr/>
        </p:nvSpPr>
        <p:spPr>
          <a:xfrm>
            <a:off x="1465350" y="4685392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636BA139-CACF-F8C8-90C3-CAAF45D216A5}"/>
              </a:ext>
            </a:extLst>
          </p:cNvPr>
          <p:cNvSpPr/>
          <p:nvPr/>
        </p:nvSpPr>
        <p:spPr>
          <a:xfrm>
            <a:off x="596153" y="4644108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F3894131-D46E-248A-80C7-349D3C2E3EBA}"/>
              </a:ext>
            </a:extLst>
          </p:cNvPr>
          <p:cNvSpPr/>
          <p:nvPr/>
        </p:nvSpPr>
        <p:spPr>
          <a:xfrm>
            <a:off x="6598503" y="4804325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2ECAEC83-E499-16D6-66BA-2EF36FF4C757}"/>
              </a:ext>
            </a:extLst>
          </p:cNvPr>
          <p:cNvSpPr/>
          <p:nvPr/>
        </p:nvSpPr>
        <p:spPr>
          <a:xfrm>
            <a:off x="8457715" y="2475793"/>
            <a:ext cx="432286" cy="1916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E3A0EEB-3A5A-E9CC-8478-BDF4B10D4929}"/>
              </a:ext>
            </a:extLst>
          </p:cNvPr>
          <p:cNvSpPr txBox="1"/>
          <p:nvPr/>
        </p:nvSpPr>
        <p:spPr>
          <a:xfrm>
            <a:off x="196929" y="917993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-4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3545922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2F6863D-4423-8DD3-A1CD-12AB90A428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5787" y="884393"/>
            <a:ext cx="2421146" cy="122814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DC0D988E-ECAA-3EB7-A654-269263D790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1980" y="1111095"/>
            <a:ext cx="2443043" cy="89134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5D63835-148D-D4E1-A34F-32DB1F4736F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6775" r="19781"/>
          <a:stretch/>
        </p:blipFill>
        <p:spPr>
          <a:xfrm>
            <a:off x="6189513" y="4006445"/>
            <a:ext cx="1007280" cy="141282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CBD64C7-305F-DF2E-C0DE-B788807EB427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7691" t="9023"/>
          <a:stretch/>
        </p:blipFill>
        <p:spPr>
          <a:xfrm>
            <a:off x="4290203" y="4006445"/>
            <a:ext cx="829083" cy="156838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D9E0A4E5-5176-3B3C-CF75-CA2F0CDCCD2B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1494" t="7525" r="9695" b="2555"/>
          <a:stretch/>
        </p:blipFill>
        <p:spPr>
          <a:xfrm>
            <a:off x="4060165" y="497632"/>
            <a:ext cx="1466490" cy="253941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20B9E12-8D03-3F9A-F86F-4F43747847E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55140" y="3782367"/>
            <a:ext cx="1029478" cy="186098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852896DA-EB8C-22C5-0F5D-ADFC01906BA5}"/>
              </a:ext>
            </a:extLst>
          </p:cNvPr>
          <p:cNvSpPr txBox="1"/>
          <p:nvPr/>
        </p:nvSpPr>
        <p:spPr>
          <a:xfrm>
            <a:off x="1733127" y="2366263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6 actin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283E706-BA1E-676A-2254-14AA6CE7FA05}"/>
              </a:ext>
            </a:extLst>
          </p:cNvPr>
          <p:cNvSpPr txBox="1"/>
          <p:nvPr/>
        </p:nvSpPr>
        <p:spPr>
          <a:xfrm>
            <a:off x="1670997" y="587721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6 actin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2DB3B8A-F1CC-010C-CF76-6DA2118B4794}"/>
              </a:ext>
            </a:extLst>
          </p:cNvPr>
          <p:cNvSpPr txBox="1"/>
          <p:nvPr/>
        </p:nvSpPr>
        <p:spPr>
          <a:xfrm>
            <a:off x="4194528" y="3059668"/>
            <a:ext cx="11015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6 JNK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D35EE2C-D3CF-CA2B-A775-6D5D56B39375}"/>
              </a:ext>
            </a:extLst>
          </p:cNvPr>
          <p:cNvSpPr txBox="1"/>
          <p:nvPr/>
        </p:nvSpPr>
        <p:spPr>
          <a:xfrm>
            <a:off x="4084330" y="5782945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6 JNK2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D73DB31-DD82-381D-B71C-8A0D58C8CD99}"/>
              </a:ext>
            </a:extLst>
          </p:cNvPr>
          <p:cNvSpPr txBox="1"/>
          <p:nvPr/>
        </p:nvSpPr>
        <p:spPr>
          <a:xfrm>
            <a:off x="6584045" y="3037042"/>
            <a:ext cx="1343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6 P-JNK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1952C95-3965-5B51-51B7-6AD1CC45A66C}"/>
              </a:ext>
            </a:extLst>
          </p:cNvPr>
          <p:cNvSpPr txBox="1"/>
          <p:nvPr/>
        </p:nvSpPr>
        <p:spPr>
          <a:xfrm>
            <a:off x="6129863" y="5749071"/>
            <a:ext cx="1465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6 P-JNK2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25354E1-6A25-19D4-8CCD-74996C0B2D9C}"/>
              </a:ext>
            </a:extLst>
          </p:cNvPr>
          <p:cNvSpPr txBox="1"/>
          <p:nvPr/>
        </p:nvSpPr>
        <p:spPr>
          <a:xfrm>
            <a:off x="196929" y="917993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-6</a:t>
            </a:r>
            <a:endParaRPr lang="zh-CN" altLang="en-US" b="1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DEB5B0B-99BF-99EE-327B-2505E6C8DAF6}"/>
              </a:ext>
            </a:extLst>
          </p:cNvPr>
          <p:cNvSpPr/>
          <p:nvPr/>
        </p:nvSpPr>
        <p:spPr>
          <a:xfrm>
            <a:off x="1578317" y="1389082"/>
            <a:ext cx="1206301" cy="24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867554B6-A5B8-FD90-CAC1-DB190AD484AD}"/>
              </a:ext>
            </a:extLst>
          </p:cNvPr>
          <p:cNvSpPr/>
          <p:nvPr/>
        </p:nvSpPr>
        <p:spPr>
          <a:xfrm>
            <a:off x="4320354" y="1498465"/>
            <a:ext cx="1206301" cy="24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80C7F9AA-785E-A5CC-FCB4-D3A987C6CF18}"/>
              </a:ext>
            </a:extLst>
          </p:cNvPr>
          <p:cNvSpPr/>
          <p:nvPr/>
        </p:nvSpPr>
        <p:spPr>
          <a:xfrm>
            <a:off x="6721382" y="1642973"/>
            <a:ext cx="1206301" cy="248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4DB61588-D7DC-0416-A3CC-258BEB8D3889}"/>
              </a:ext>
            </a:extLst>
          </p:cNvPr>
          <p:cNvSpPr/>
          <p:nvPr/>
        </p:nvSpPr>
        <p:spPr>
          <a:xfrm>
            <a:off x="6212517" y="4635372"/>
            <a:ext cx="874460" cy="241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3D12F68E-5C5F-06BA-1D56-7D799BD5B122}"/>
              </a:ext>
            </a:extLst>
          </p:cNvPr>
          <p:cNvSpPr/>
          <p:nvPr/>
        </p:nvSpPr>
        <p:spPr>
          <a:xfrm>
            <a:off x="4320354" y="4457001"/>
            <a:ext cx="874460" cy="241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3AA98C7B-6711-8A41-BD04-09DF6E3B5904}"/>
              </a:ext>
            </a:extLst>
          </p:cNvPr>
          <p:cNvSpPr/>
          <p:nvPr/>
        </p:nvSpPr>
        <p:spPr>
          <a:xfrm>
            <a:off x="1905803" y="4474355"/>
            <a:ext cx="874460" cy="241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5467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5</TotalTime>
  <Words>213</Words>
  <Application>Microsoft Office PowerPoint</Application>
  <PresentationFormat>宽屏</PresentationFormat>
  <Paragraphs>75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良建 马</dc:creator>
  <cp:lastModifiedBy>良建 马</cp:lastModifiedBy>
  <cp:revision>11</cp:revision>
  <dcterms:created xsi:type="dcterms:W3CDTF">2024-08-23T03:33:01Z</dcterms:created>
  <dcterms:modified xsi:type="dcterms:W3CDTF">2024-11-11T07:30:51Z</dcterms:modified>
</cp:coreProperties>
</file>